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5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66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140" autoAdjust="0"/>
  </p:normalViewPr>
  <p:slideViewPr>
    <p:cSldViewPr snapToGrid="0">
      <p:cViewPr varScale="1">
        <p:scale>
          <a:sx n="77" d="100"/>
          <a:sy n="77" d="100"/>
        </p:scale>
        <p:origin x="3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E94B2D-07F7-458A-87E3-485A4D884D54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892"/>
            <a:ext cx="548640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687F9-746E-40BC-875D-08F4D7275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4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51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64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982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15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720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53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7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604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0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182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396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BF23C-F1A1-43C5-9797-15967F6B4DF3}" type="datetimeFigureOut">
              <a:rPr lang="en-US" smtClean="0"/>
              <a:t>12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0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794164F-532D-4180-BCF6-607844BEC9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4483643"/>
              </p:ext>
            </p:extLst>
          </p:nvPr>
        </p:nvGraphicFramePr>
        <p:xfrm>
          <a:off x="715963" y="1252624"/>
          <a:ext cx="2378075" cy="2087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2" name="Prism 9" r:id="rId3" imgW="3819239" imgH="3186643" progId="Prism9.Document">
                  <p:embed/>
                </p:oleObj>
              </mc:Choice>
              <mc:Fallback>
                <p:oleObj name="Prism 9" r:id="rId3" imgW="3819239" imgH="3186643" progId="Prism9.Document">
                  <p:embed/>
                  <p:pic>
                    <p:nvPicPr>
                      <p:cNvPr id="8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5963" y="1252624"/>
                        <a:ext cx="2378075" cy="20875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37B3860-2AF6-4D04-8EE2-4C872FB267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2592105"/>
              </p:ext>
            </p:extLst>
          </p:nvPr>
        </p:nvGraphicFramePr>
        <p:xfrm>
          <a:off x="3103563" y="1230399"/>
          <a:ext cx="2274887" cy="2130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3" name="Prism 9" r:id="rId5" imgW="3736768" imgH="3186643" progId="Prism9.Document">
                  <p:embed/>
                </p:oleObj>
              </mc:Choice>
              <mc:Fallback>
                <p:oleObj name="Prism 9" r:id="rId5" imgW="3736768" imgH="3186643" progId="Prism9.Document">
                  <p:embed/>
                  <p:pic>
                    <p:nvPicPr>
                      <p:cNvPr id="9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03563" y="1230399"/>
                        <a:ext cx="2274887" cy="2130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:a16="http://schemas.microsoft.com/office/drawing/2014/main" id="{6F3E3CDB-0369-419B-A3BF-300E0818A921}"/>
              </a:ext>
            </a:extLst>
          </p:cNvPr>
          <p:cNvSpPr/>
          <p:nvPr/>
        </p:nvSpPr>
        <p:spPr>
          <a:xfrm>
            <a:off x="607959" y="3352526"/>
            <a:ext cx="562530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Supplementary Figure 5.</a:t>
            </a:r>
            <a:endParaRPr lang="en-US" sz="1200" dirty="0">
              <a:cs typeface="Arial" panose="020B0604020202020204" pitchFamily="34" charset="0"/>
            </a:endParaRPr>
          </a:p>
          <a:p>
            <a:r>
              <a:rPr lang="en-US" sz="1200" dirty="0">
                <a:cs typeface="Arial" panose="020B0604020202020204" pitchFamily="34" charset="0"/>
              </a:rPr>
              <a:t>Pharmacokinetics of intravesical BCG in tumor-bearing bladders of mice. </a:t>
            </a:r>
          </a:p>
          <a:p>
            <a:r>
              <a:rPr lang="en-US" sz="1200" dirty="0"/>
              <a:t>Mice bearing bladder tumors received a single dose intravesical injection of vehicle or 1mg </a:t>
            </a:r>
            <a:r>
              <a:rPr lang="en-US" sz="1200" dirty="0">
                <a:ea typeface="Yu Gothic" panose="020B0400000000000000" pitchFamily="34" charset="-128"/>
              </a:rPr>
              <a:t>BCG</a:t>
            </a:r>
            <a:r>
              <a:rPr lang="en-US" sz="1200" dirty="0"/>
              <a:t>. Bladders were collected at 6 hours and 24 hours. Fold change was calculated by comparing to vehicle treatment which is considered as one. </a:t>
            </a:r>
            <a:endParaRPr lang="en-US" sz="1200" b="1" dirty="0"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F016BC-711E-4BFF-9796-3ED1E567995C}"/>
              </a:ext>
            </a:extLst>
          </p:cNvPr>
          <p:cNvSpPr txBox="1"/>
          <p:nvPr/>
        </p:nvSpPr>
        <p:spPr>
          <a:xfrm>
            <a:off x="739775" y="1273012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ACA7160-2114-411F-A67E-8FEBD7218A0B}"/>
              </a:ext>
            </a:extLst>
          </p:cNvPr>
          <p:cNvSpPr txBox="1"/>
          <p:nvPr/>
        </p:nvSpPr>
        <p:spPr>
          <a:xfrm>
            <a:off x="3102896" y="1284554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1C949E5-E3AD-4A25-B5BF-8D06F1D3E330}"/>
              </a:ext>
            </a:extLst>
          </p:cNvPr>
          <p:cNvSpPr txBox="1"/>
          <p:nvPr/>
        </p:nvSpPr>
        <p:spPr>
          <a:xfrm>
            <a:off x="4169016" y="219295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3524727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41</TotalTime>
  <Words>60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Yu Gothic</vt:lpstr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lena Prabagar</dc:creator>
  <cp:lastModifiedBy>Miglena Prabagar</cp:lastModifiedBy>
  <cp:revision>301</cp:revision>
  <cp:lastPrinted>2024-06-07T20:20:11Z</cp:lastPrinted>
  <dcterms:created xsi:type="dcterms:W3CDTF">2021-09-21T12:05:42Z</dcterms:created>
  <dcterms:modified xsi:type="dcterms:W3CDTF">2024-12-11T14:41:37Z</dcterms:modified>
</cp:coreProperties>
</file>